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305" r:id="rId2"/>
    <p:sldId id="306" r:id="rId3"/>
    <p:sldId id="307" r:id="rId4"/>
    <p:sldId id="312" r:id="rId5"/>
  </p:sldIdLst>
  <p:sldSz cx="7561263" cy="10693400"/>
  <p:notesSz cx="7104063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2">
          <p15:clr>
            <a:srgbClr val="A4A3A4"/>
          </p15:clr>
        </p15:guide>
        <p15:guide id="3" pos="238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nka" initials="L" lastIdx="5" clrIdx="0"/>
  <p:cmAuthor id="2" name="Stephen Fry" initials="SF" lastIdx="2" clrIdx="1"/>
  <p:cmAuthor id="3" name="Lenka Frankova" initials="LF" lastIdx="2" clrIdx="2">
    <p:extLst>
      <p:ext uri="{19B8F6BF-5375-455C-9EA6-DF929625EA0E}">
        <p15:presenceInfo xmlns:p15="http://schemas.microsoft.com/office/powerpoint/2012/main" userId="S-1-5-21-861567501-1417001333-682003330-29434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FF"/>
    <a:srgbClr val="FF00FF"/>
    <a:srgbClr val="00CCFF"/>
    <a:srgbClr val="E2AC00"/>
    <a:srgbClr val="0066FF"/>
    <a:srgbClr val="6699FF"/>
    <a:srgbClr val="6600CC"/>
    <a:srgbClr val="009900"/>
    <a:srgbClr val="FF0066"/>
    <a:srgbClr val="00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361" autoAdjust="0"/>
    <p:restoredTop sz="95501" autoAdjust="0"/>
  </p:normalViewPr>
  <p:slideViewPr>
    <p:cSldViewPr>
      <p:cViewPr varScale="1">
        <p:scale>
          <a:sx n="102" d="100"/>
          <a:sy n="102" d="100"/>
        </p:scale>
        <p:origin x="1188" y="114"/>
      </p:cViewPr>
      <p:guideLst>
        <p:guide orient="horz" pos="3368"/>
        <p:guide pos="2382"/>
        <p:guide pos="238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4" y="3"/>
            <a:ext cx="3078981" cy="511730"/>
          </a:xfrm>
          <a:prstGeom prst="rect">
            <a:avLst/>
          </a:prstGeom>
        </p:spPr>
        <p:txBody>
          <a:bodyPr vert="horz" lIns="95506" tIns="47753" rIns="95506" bIns="47753" rtlCol="0"/>
          <a:lstStyle>
            <a:lvl1pPr algn="l">
              <a:defRPr sz="13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427" y="3"/>
            <a:ext cx="3078981" cy="511730"/>
          </a:xfrm>
          <a:prstGeom prst="rect">
            <a:avLst/>
          </a:prstGeom>
        </p:spPr>
        <p:txBody>
          <a:bodyPr vert="horz" lIns="95506" tIns="47753" rIns="95506" bIns="47753" rtlCol="0"/>
          <a:lstStyle>
            <a:lvl1pPr algn="r">
              <a:defRPr sz="1300"/>
            </a:lvl1pPr>
          </a:lstStyle>
          <a:p>
            <a:fld id="{FBFEE0D7-97D0-4436-B2DB-E0C32494AADB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765175"/>
            <a:ext cx="2716213" cy="3840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06" tIns="47753" rIns="95506" bIns="47753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407" y="4861442"/>
            <a:ext cx="5683250" cy="4605576"/>
          </a:xfrm>
          <a:prstGeom prst="rect">
            <a:avLst/>
          </a:prstGeom>
        </p:spPr>
        <p:txBody>
          <a:bodyPr vert="horz" lIns="95506" tIns="47753" rIns="95506" bIns="47753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4" y="9721244"/>
            <a:ext cx="3078981" cy="511730"/>
          </a:xfrm>
          <a:prstGeom prst="rect">
            <a:avLst/>
          </a:prstGeom>
        </p:spPr>
        <p:txBody>
          <a:bodyPr vert="horz" lIns="95506" tIns="47753" rIns="95506" bIns="47753" rtlCol="0" anchor="b"/>
          <a:lstStyle>
            <a:lvl1pPr algn="l">
              <a:defRPr sz="13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427" y="9721244"/>
            <a:ext cx="3078981" cy="511730"/>
          </a:xfrm>
          <a:prstGeom prst="rect">
            <a:avLst/>
          </a:prstGeom>
        </p:spPr>
        <p:txBody>
          <a:bodyPr vert="horz" lIns="95506" tIns="47753" rIns="95506" bIns="47753" rtlCol="0" anchor="b"/>
          <a:lstStyle>
            <a:lvl1pPr algn="r">
              <a:defRPr sz="1300"/>
            </a:lvl1pPr>
          </a:lstStyle>
          <a:p>
            <a:fld id="{271F0BAA-E2E1-4537-B541-507954425F58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829383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34133" y="668338"/>
            <a:ext cx="1405923" cy="142256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2427" y="668338"/>
            <a:ext cx="4095684" cy="142256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2428" y="3891210"/>
            <a:ext cx="2750147" cy="11002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8595" y="3891210"/>
            <a:ext cx="2751460" cy="11002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B3A76-DAB5-42C5-95D6-600E07ECFC49}" type="datetimeFigureOut">
              <a:rPr lang="en-GB" smtClean="0"/>
              <a:pPr/>
              <a:t>06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730AA2-8B70-4F1C-9CE6-14013E30A959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"/><Relationship Id="rId3" Type="http://schemas.openxmlformats.org/officeDocument/2006/relationships/image" Target="../media/image12.tiff"/><Relationship Id="rId7" Type="http://schemas.openxmlformats.org/officeDocument/2006/relationships/image" Target="../media/image16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11" Type="http://schemas.openxmlformats.org/officeDocument/2006/relationships/image" Target="../media/image20.tif"/><Relationship Id="rId5" Type="http://schemas.openxmlformats.org/officeDocument/2006/relationships/image" Target="../media/image14.tiff"/><Relationship Id="rId10" Type="http://schemas.openxmlformats.org/officeDocument/2006/relationships/image" Target="../media/image19.tif"/><Relationship Id="rId4" Type="http://schemas.openxmlformats.org/officeDocument/2006/relationships/image" Target="../media/image13.tiff"/><Relationship Id="rId9" Type="http://schemas.openxmlformats.org/officeDocument/2006/relationships/image" Target="../media/image18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8" descr="F6KGMThymol+60C+5,M-85"/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716735" y="594172"/>
            <a:ext cx="491680" cy="18611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29" descr="F7KGMThymolM-90,C+10"/>
          <p:cNvPicPr>
            <a:picLocks noChangeAspect="1" noChangeArrowheads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5207621" y="594172"/>
            <a:ext cx="864096" cy="18573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 Box 96"/>
          <p:cNvSpPr txBox="1">
            <a:spLocks noChangeArrowheads="1"/>
          </p:cNvSpPr>
          <p:nvPr/>
        </p:nvSpPr>
        <p:spPr bwMode="auto">
          <a:xfrm>
            <a:off x="4644727" y="2408711"/>
            <a:ext cx="259197" cy="6178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hara CE</a:t>
            </a:r>
            <a:endParaRPr kumimoji="0" lang="en-GB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96"/>
          <p:cNvSpPr txBox="1">
            <a:spLocks noChangeArrowheads="1"/>
          </p:cNvSpPr>
          <p:nvPr/>
        </p:nvSpPr>
        <p:spPr bwMode="auto">
          <a:xfrm>
            <a:off x="4860751" y="2408711"/>
            <a:ext cx="259197" cy="6178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hara AS</a:t>
            </a:r>
            <a:endParaRPr kumimoji="0" lang="en-GB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96"/>
          <p:cNvSpPr txBox="1">
            <a:spLocks noChangeArrowheads="1"/>
          </p:cNvSpPr>
          <p:nvPr/>
        </p:nvSpPr>
        <p:spPr bwMode="auto">
          <a:xfrm>
            <a:off x="5321634" y="2395674"/>
            <a:ext cx="259197" cy="6178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itella CE</a:t>
            </a:r>
            <a:endParaRPr kumimoji="0" lang="en-GB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96"/>
          <p:cNvSpPr txBox="1">
            <a:spLocks noChangeArrowheads="1"/>
          </p:cNvSpPr>
          <p:nvPr/>
        </p:nvSpPr>
        <p:spPr bwMode="auto">
          <a:xfrm>
            <a:off x="5537658" y="2395674"/>
            <a:ext cx="259197" cy="6178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itella AS</a:t>
            </a:r>
            <a:endParaRPr kumimoji="0" lang="en-GB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96"/>
          <p:cNvSpPr txBox="1">
            <a:spLocks noChangeArrowheads="1"/>
          </p:cNvSpPr>
          <p:nvPr/>
        </p:nvSpPr>
        <p:spPr bwMode="auto">
          <a:xfrm>
            <a:off x="5070508" y="2408711"/>
            <a:ext cx="259197" cy="6178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hara CW</a:t>
            </a:r>
            <a:endParaRPr kumimoji="0" lang="en-GB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96"/>
          <p:cNvSpPr txBox="1">
            <a:spLocks noChangeArrowheads="1"/>
          </p:cNvSpPr>
          <p:nvPr/>
        </p:nvSpPr>
        <p:spPr bwMode="auto">
          <a:xfrm>
            <a:off x="5753682" y="2394372"/>
            <a:ext cx="259197" cy="6178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itella CW</a:t>
            </a:r>
            <a:endParaRPr kumimoji="0" lang="en-GB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47525" y="306140"/>
            <a:ext cx="3096000" cy="2825838"/>
          </a:xfrm>
          <a:prstGeom prst="rect">
            <a:avLst/>
          </a:prstGeom>
        </p:spPr>
      </p:pic>
      <p:sp>
        <p:nvSpPr>
          <p:cNvPr id="16" name="Rectangle 601"/>
          <p:cNvSpPr>
            <a:spLocks noChangeArrowheads="1"/>
          </p:cNvSpPr>
          <p:nvPr/>
        </p:nvSpPr>
        <p:spPr bwMode="auto">
          <a:xfrm>
            <a:off x="915689" y="501839"/>
            <a:ext cx="2880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6000" tIns="0" rIns="36000" bIns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(A)</a:t>
            </a:r>
            <a:endParaRPr kumimoji="0" lang="en-GB" sz="12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Rectangle 601"/>
          <p:cNvSpPr>
            <a:spLocks noChangeArrowheads="1"/>
          </p:cNvSpPr>
          <p:nvPr/>
        </p:nvSpPr>
        <p:spPr bwMode="auto">
          <a:xfrm>
            <a:off x="4360032" y="501839"/>
            <a:ext cx="2880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6000" tIns="0" rIns="36000" bIns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(B)</a:t>
            </a:r>
            <a:endParaRPr kumimoji="0" lang="en-GB" sz="12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68819" y="3402396"/>
            <a:ext cx="6480720" cy="25871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Figure S1. Trans-</a:t>
            </a:r>
            <a:r>
              <a:rPr lang="el-GR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β</a:t>
            </a:r>
            <a:r>
              <a:rPr lang="en-GB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-mannanase vs. hydrolase activities in extracts from </a:t>
            </a:r>
            <a:r>
              <a:rPr lang="en-GB" sz="1000" b="1" i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hara vulgaris</a:t>
            </a:r>
            <a:r>
              <a:rPr lang="en-GB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b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                   and </a:t>
            </a:r>
            <a:r>
              <a:rPr lang="en-GB" sz="1000" b="1" i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Nitella flexilis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endParaRPr lang="en-GB" sz="1000" i="1" dirty="0"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  <a:p>
            <a:pPr marL="457200" fontAlgn="base">
              <a:lnSpc>
                <a:spcPct val="107000"/>
              </a:lnSpc>
              <a:spcAft>
                <a:spcPts val="800"/>
              </a:spcAft>
            </a:pP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zyme preparations from the two species were CE (=crude extract), AS (=ammonium sulphate pelleted proteins), and CW (= cell wall extract). Each preparation was incubated in a mixture containing 3 mg/ml non-radioactive glucomannan plus a trace (0.2 µM) of [</a:t>
            </a:r>
            <a:r>
              <a:rPr lang="en-GB" sz="1000" kern="100" baseline="300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]Man</a:t>
            </a:r>
            <a:r>
              <a:rPr lang="en-GB" sz="1000" kern="100" baseline="-250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ol. The reaction products were analysed by TLC. Panel (A) shows relative trans-β-mannanase activity (transglycosylation products with donor = glucomannan and acceptor = Man</a:t>
            </a:r>
            <a:r>
              <a:rPr lang="en-GB" sz="1000" kern="100" baseline="-250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ol), indicated by radioactivity remaining within 0.5 cm of the TLC plate origin. In panel (B), the rest of the TLC was thymol-stained for carbohydrate; chromatographically mobile spots indicate hydrolysis products of the otherwise immobile glucomannan. Quite probably, a proportion of the tracer-level [</a:t>
            </a:r>
            <a:r>
              <a:rPr lang="en-GB" sz="1000" kern="100" baseline="300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]Man</a:t>
            </a:r>
            <a:r>
              <a:rPr lang="en-GB" sz="1000" kern="100" baseline="-250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ol was also hydrolysed to smaller products, but these would be below the limit of detection by thymol staining. Thus, trans-β-mannanase (A) and mannan hydrolase activities (B) are detectable in the same reaction mixture analysed on a single TLC plate. Note that </a:t>
            </a:r>
            <a:r>
              <a:rPr lang="en-GB" sz="1000" i="1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ra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rude extracts possess high trans-β-mannanase activity but only barely detectable hydrolase activity, unlike </a:t>
            </a:r>
            <a:r>
              <a:rPr lang="en-GB" sz="1000" i="1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itella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000" i="1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ra</a:t>
            </a:r>
            <a:r>
              <a:rPr lang="en-GB" sz="1000" kern="100" dirty="0">
                <a:solidFill>
                  <a:srgbClr val="24242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 thereby distinguished from its close relative.</a:t>
            </a:r>
            <a:endParaRPr lang="en-GB" sz="1000" dirty="0"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17" name="Text Box 96"/>
          <p:cNvSpPr txBox="1">
            <a:spLocks noChangeArrowheads="1"/>
          </p:cNvSpPr>
          <p:nvPr/>
        </p:nvSpPr>
        <p:spPr bwMode="auto">
          <a:xfrm>
            <a:off x="1282883" y="2184874"/>
            <a:ext cx="88467" cy="201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lIns="27432" tIns="22860" rIns="27432" bIns="2286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altLang="ja-JP" sz="700" b="1" kern="0" dirty="0">
                <a:solidFill>
                  <a:srgbClr val="000000">
                    <a:lumMod val="75000"/>
                    <a:lumOff val="25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GB" altLang="ja-JP" sz="700" b="1" i="0" u="none" strike="noStrike" kern="0" cap="none" spc="0" normalizeH="0" baseline="0" noProof="0" dirty="0">
              <a:ln>
                <a:noFill/>
              </a:ln>
              <a:solidFill>
                <a:srgbClr val="000000">
                  <a:lumMod val="75000"/>
                  <a:lumOff val="25000"/>
                </a:srgbClr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87B6C363-276B-3C34-FE3E-4FCC1FD20C2B}"/>
              </a:ext>
            </a:extLst>
          </p:cNvPr>
          <p:cNvCxnSpPr>
            <a:cxnSpLocks/>
          </p:cNvCxnSpPr>
          <p:nvPr/>
        </p:nvCxnSpPr>
        <p:spPr>
          <a:xfrm>
            <a:off x="5207621" y="594172"/>
            <a:ext cx="0" cy="188635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CD483FEA-04BD-871B-3C60-2F7B1B6176B2}"/>
              </a:ext>
            </a:extLst>
          </p:cNvPr>
          <p:cNvSpPr/>
          <p:nvPr/>
        </p:nvSpPr>
        <p:spPr>
          <a:xfrm>
            <a:off x="4716735" y="594172"/>
            <a:ext cx="1354982" cy="185731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681987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5045" y="312504"/>
            <a:ext cx="3800003" cy="18540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9911" y="2130167"/>
            <a:ext cx="3800003" cy="18540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0131" y="3958497"/>
            <a:ext cx="3800003" cy="18540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29951" y="306140"/>
            <a:ext cx="3800003" cy="1854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44941" y="2150612"/>
            <a:ext cx="3800003" cy="18540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36245" y="3974913"/>
            <a:ext cx="3834601" cy="1854000"/>
          </a:xfrm>
          <a:prstGeom prst="rect">
            <a:avLst/>
          </a:prstGeom>
        </p:spPr>
      </p:pic>
      <p:grpSp>
        <p:nvGrpSpPr>
          <p:cNvPr id="19" name="Group 18"/>
          <p:cNvGrpSpPr>
            <a:grpSpLocks noChangeAspect="1"/>
          </p:cNvGrpSpPr>
          <p:nvPr/>
        </p:nvGrpSpPr>
        <p:grpSpPr>
          <a:xfrm>
            <a:off x="2461331" y="430493"/>
            <a:ext cx="4810598" cy="4261733"/>
            <a:chOff x="2438643" y="937525"/>
            <a:chExt cx="4914608" cy="4353875"/>
          </a:xfrm>
        </p:grpSpPr>
        <p:sp>
          <p:nvSpPr>
            <p:cNvPr id="10" name="Text Box 8"/>
            <p:cNvSpPr txBox="1">
              <a:spLocks noChangeArrowheads="1"/>
            </p:cNvSpPr>
            <p:nvPr/>
          </p:nvSpPr>
          <p:spPr bwMode="auto">
            <a:xfrm>
              <a:off x="6137702" y="937525"/>
              <a:ext cx="1215549" cy="3064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lvl="0" algn="r">
                <a:spcAft>
                  <a:spcPts val="1000"/>
                </a:spcAft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5%  -  505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 Box 9"/>
            <p:cNvSpPr txBox="1">
              <a:spLocks noChangeArrowheads="1"/>
            </p:cNvSpPr>
            <p:nvPr/>
          </p:nvSpPr>
          <p:spPr bwMode="auto">
            <a:xfrm>
              <a:off x="6116974" y="2825257"/>
              <a:ext cx="1215549" cy="304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lvl="0" algn="r">
                <a:spcAft>
                  <a:spcPts val="1000"/>
                </a:spcAft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01%  -  101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 Box 10"/>
            <p:cNvSpPr txBox="1">
              <a:spLocks noChangeArrowheads="1"/>
            </p:cNvSpPr>
            <p:nvPr/>
          </p:nvSpPr>
          <p:spPr bwMode="auto">
            <a:xfrm>
              <a:off x="5643279" y="4729767"/>
              <a:ext cx="1618426" cy="5616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%  =</a:t>
              </a:r>
            </a:p>
            <a:p>
              <a:pPr lvl="0" algn="r"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0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 cold Man</a:t>
              </a:r>
              <a:r>
                <a:rPr kumimoji="0" lang="en-GB" sz="1000" b="1" i="0" u="none" strike="noStrike" kern="0" cap="none" spc="0" normalizeH="0" baseline="-25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lvl="0" algn="r"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 hot [</a:t>
              </a:r>
              <a:r>
                <a:rPr kumimoji="0" lang="en-GB" sz="1000" b="1" i="0" u="none" strike="noStrike" kern="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kumimoji="0" lang="en-GB" sz="1000" b="1" i="0" u="none" strike="noStrike" kern="0" cap="none" spc="0" normalizeH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]Man</a:t>
              </a:r>
              <a:r>
                <a:rPr kumimoji="0" lang="en-GB" sz="1000" b="1" i="0" u="none" strike="noStrike" kern="0" cap="none" spc="0" normalizeH="0" baseline="-25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kumimoji="0" lang="en-GB" sz="1000" b="1" i="0" u="none" strike="noStrike" kern="0" cap="none" spc="0" normalizeH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ol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0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 Box 11"/>
            <p:cNvSpPr txBox="1">
              <a:spLocks noChangeArrowheads="1"/>
            </p:cNvSpPr>
            <p:nvPr/>
          </p:nvSpPr>
          <p:spPr bwMode="auto">
            <a:xfrm>
              <a:off x="2450488" y="944929"/>
              <a:ext cx="1217030" cy="304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lvl="0" algn="r">
                <a:spcAft>
                  <a:spcPts val="1000"/>
                </a:spcAft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3%  -  3027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 Box 12"/>
            <p:cNvSpPr txBox="1">
              <a:spLocks noChangeArrowheads="1"/>
            </p:cNvSpPr>
            <p:nvPr/>
          </p:nvSpPr>
          <p:spPr bwMode="auto">
            <a:xfrm>
              <a:off x="2447527" y="2825257"/>
              <a:ext cx="1215549" cy="304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lvl="0" algn="r">
                <a:spcAft>
                  <a:spcPts val="1000"/>
                </a:spcAft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%  -  2018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 Box 13"/>
            <p:cNvSpPr txBox="1">
              <a:spLocks noChangeArrowheads="1"/>
            </p:cNvSpPr>
            <p:nvPr/>
          </p:nvSpPr>
          <p:spPr bwMode="auto">
            <a:xfrm>
              <a:off x="2438643" y="4705586"/>
              <a:ext cx="1215549" cy="304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lvl="0" algn="r">
                <a:spcAft>
                  <a:spcPts val="1000"/>
                </a:spcAft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%  -  1010 </a:t>
              </a:r>
              <a:r>
                <a:rPr lang="en-GB" sz="1000" b="1" kern="0" dirty="0">
                  <a:latin typeface="Symbol" pitchFamily="18" charset="2"/>
                </a:rPr>
                <a:t>m</a:t>
              </a: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70" descr="radioactive_sign_02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 rot="5479340">
              <a:off x="7187472" y="5103726"/>
              <a:ext cx="134732" cy="134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8" name="Rectangle 17"/>
          <p:cNvSpPr/>
          <p:nvPr/>
        </p:nvSpPr>
        <p:spPr>
          <a:xfrm>
            <a:off x="612279" y="5972901"/>
            <a:ext cx="6480720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esting the optimal oligomannan concentration for trans-β-mannanase activity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from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hara vulgaris</a:t>
            </a:r>
          </a:p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e reaction mixtures contained 0.1–3.0 mg/ml (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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100–3000 µM) non-radioactive 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0.1 µM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ol. Control sample was free of donor (0% 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The incorporation of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ol into mannan oligosaccharide was profiled in radioisotope scanner.  The x-axis shows distance migrated on the TLC plate. The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axis shows the detected 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 beta-particles per 0.8-mm segment of the TLC plate as measured in a 30-minute exposure on the LabLogic radioisotope scanner. The values displayed above each peak are expressed as % of total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ol used in the assay. The magenta peak at ~3 cm is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ol; peaks to its right are progressively smaller (mainly DP 5, 4 and 3) and those to its left are larger (with the peak at ‘0 cm’ being chromatographically immobile; polysaccharides and large oligosaccharides). </a:t>
            </a:r>
          </a:p>
        </p:txBody>
      </p:sp>
    </p:spTree>
    <p:extLst>
      <p:ext uri="{BB962C8B-B14F-4D97-AF65-F5344CB8AC3E}">
        <p14:creationId xmlns:p14="http://schemas.microsoft.com/office/powerpoint/2010/main" val="826333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7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19350" y="2781509"/>
            <a:ext cx="2520000" cy="453034"/>
          </a:xfrm>
          <a:prstGeom prst="rect">
            <a:avLst/>
          </a:prstGeom>
        </p:spPr>
      </p:pic>
      <p:pic>
        <p:nvPicPr>
          <p:cNvPr id="4" name="Picture 3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23160" y="2267629"/>
            <a:ext cx="2519680" cy="452120"/>
          </a:xfrm>
          <a:prstGeom prst="rect">
            <a:avLst/>
          </a:prstGeom>
        </p:spPr>
      </p:pic>
      <p:pic>
        <p:nvPicPr>
          <p:cNvPr id="6" name="Picture 5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23795" y="1751374"/>
            <a:ext cx="2519680" cy="452120"/>
          </a:xfrm>
          <a:prstGeom prst="rect">
            <a:avLst/>
          </a:prstGeom>
        </p:spPr>
      </p:pic>
      <p:pic>
        <p:nvPicPr>
          <p:cNvPr id="8" name="Picture 7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19350" y="1242739"/>
            <a:ext cx="2519680" cy="452120"/>
          </a:xfrm>
          <a:prstGeom prst="rect">
            <a:avLst/>
          </a:prstGeom>
        </p:spPr>
      </p:pic>
      <p:pic>
        <p:nvPicPr>
          <p:cNvPr id="9" name="Picture 8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23795" y="734739"/>
            <a:ext cx="2519680" cy="452755"/>
          </a:xfrm>
          <a:prstGeom prst="rect">
            <a:avLst/>
          </a:prstGeom>
        </p:spPr>
      </p:pic>
      <p:sp>
        <p:nvSpPr>
          <p:cNvPr id="12" name="TextBox 21"/>
          <p:cNvSpPr txBox="1"/>
          <p:nvPr/>
        </p:nvSpPr>
        <p:spPr>
          <a:xfrm>
            <a:off x="567815" y="925239"/>
            <a:ext cx="960755" cy="16510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80% EtOH + 0.5% AA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TextBox 21"/>
          <p:cNvSpPr txBox="1"/>
          <p:nvPr/>
        </p:nvSpPr>
        <p:spPr>
          <a:xfrm>
            <a:off x="567815" y="1417999"/>
            <a:ext cx="960755" cy="16510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60% EtOH + 0.5% AA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21"/>
          <p:cNvSpPr txBox="1"/>
          <p:nvPr/>
        </p:nvSpPr>
        <p:spPr>
          <a:xfrm>
            <a:off x="567815" y="1939969"/>
            <a:ext cx="960755" cy="16510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40% EtOH + 0.5% AA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TextBox 21"/>
          <p:cNvSpPr txBox="1"/>
          <p:nvPr/>
        </p:nvSpPr>
        <p:spPr>
          <a:xfrm>
            <a:off x="567815" y="2468924"/>
            <a:ext cx="960755" cy="16510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20% EtOH + 0.5% AA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6" name="TextBox 21"/>
          <p:cNvSpPr txBox="1"/>
          <p:nvPr/>
        </p:nvSpPr>
        <p:spPr>
          <a:xfrm>
            <a:off x="567815" y="2953429"/>
            <a:ext cx="960755" cy="16510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0% EtOH + 0.5% AA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7" name="TextBox 21"/>
          <p:cNvSpPr txBox="1"/>
          <p:nvPr/>
        </p:nvSpPr>
        <p:spPr>
          <a:xfrm>
            <a:off x="4599430" y="545509"/>
            <a:ext cx="1565910" cy="22225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1000" b="1" kern="1200" dirty="0">
                <a:solidFill>
                  <a:srgbClr val="FF505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oc-It UV 254 nm</a:t>
            </a:r>
            <a:r>
              <a:rPr lang="en-GB" sz="1000" b="1" kern="1200" baseline="-25000" dirty="0">
                <a:solidFill>
                  <a:srgbClr val="FF505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1000" b="1" kern="1200" dirty="0">
                <a:solidFill>
                  <a:srgbClr val="FF505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+ green filter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21"/>
          <p:cNvSpPr txBox="1"/>
          <p:nvPr/>
        </p:nvSpPr>
        <p:spPr>
          <a:xfrm>
            <a:off x="2300730" y="551859"/>
            <a:ext cx="1073150" cy="18288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fontAlgn="base"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1000" b="1" kern="1200" dirty="0">
                <a:solidFill>
                  <a:srgbClr val="FF505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oc-It UV 254 nm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21"/>
          <p:cNvSpPr txBox="1"/>
          <p:nvPr/>
        </p:nvSpPr>
        <p:spPr>
          <a:xfrm rot="16200000">
            <a:off x="1120900" y="3689394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quisetum fluviatile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3 M Succ + Glyc + Asc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0" name="TextBox 21"/>
          <p:cNvSpPr txBox="1"/>
          <p:nvPr/>
        </p:nvSpPr>
        <p:spPr>
          <a:xfrm rot="16200000">
            <a:off x="1461895" y="3689394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quisetum fluviatil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solidFill>
                  <a:srgbClr val="FF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30% sat’d AS cut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GB" sz="800" b="1" kern="1200" dirty="0">
                <a:solidFill>
                  <a:srgbClr val="00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" name="TextBox 21"/>
          <p:cNvSpPr txBox="1"/>
          <p:nvPr/>
        </p:nvSpPr>
        <p:spPr>
          <a:xfrm rot="16200000">
            <a:off x="2133090" y="3689394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solidFill>
                  <a:srgbClr val="FF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70% sat’d AS cut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GB" sz="800" b="1" kern="1200" dirty="0">
                <a:solidFill>
                  <a:srgbClr val="00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810510" y="3689394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3 M Succ + Glyc + Asc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3" name="TextBox 21"/>
          <p:cNvSpPr txBox="1"/>
          <p:nvPr/>
        </p:nvSpPr>
        <p:spPr>
          <a:xfrm rot="16200000">
            <a:off x="2477578" y="3618591"/>
            <a:ext cx="1079500" cy="413385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xenic 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2M Succ + 1 M NaCl + 5% Glyc + 0.02 M Triton-X100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5" name="TextBox 21"/>
          <p:cNvSpPr txBox="1"/>
          <p:nvPr/>
        </p:nvSpPr>
        <p:spPr>
          <a:xfrm rot="16200000">
            <a:off x="3174490" y="3689394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quisetum arvense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165 M </a:t>
            </a:r>
            <a:r>
              <a:rPr lang="en-GB" sz="800" b="1" dirty="0"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trate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TextBox 21"/>
          <p:cNvSpPr txBox="1"/>
          <p:nvPr/>
        </p:nvSpPr>
        <p:spPr>
          <a:xfrm rot="16200000">
            <a:off x="3707890" y="3686219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quisetum fluviatile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3 M Succ + Glyc + Asc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TextBox 21"/>
          <p:cNvSpPr txBox="1"/>
          <p:nvPr/>
        </p:nvSpPr>
        <p:spPr>
          <a:xfrm rot="16200000">
            <a:off x="4048885" y="3686219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quisetum fluviatil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solidFill>
                  <a:srgbClr val="FF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30% sat’d AS cut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GB" sz="800" b="1" kern="1200" dirty="0">
                <a:solidFill>
                  <a:srgbClr val="00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TextBox 21"/>
          <p:cNvSpPr txBox="1"/>
          <p:nvPr/>
        </p:nvSpPr>
        <p:spPr>
          <a:xfrm rot="16200000">
            <a:off x="4720080" y="3686219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solidFill>
                  <a:srgbClr val="FF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70% sat’d AS cut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GB" sz="800" b="1" kern="1200" dirty="0">
                <a:solidFill>
                  <a:srgbClr val="0000FF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TextBox 21"/>
          <p:cNvSpPr txBox="1"/>
          <p:nvPr/>
        </p:nvSpPr>
        <p:spPr>
          <a:xfrm rot="16200000">
            <a:off x="4397500" y="3686219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3 M Succ + Glyc + Asc</a:t>
            </a: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TextBox 21"/>
          <p:cNvSpPr txBox="1"/>
          <p:nvPr/>
        </p:nvSpPr>
        <p:spPr>
          <a:xfrm rot="16200000">
            <a:off x="5059488" y="3605891"/>
            <a:ext cx="1079500" cy="413385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Axenic 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2M Succ + 1 M NaCl + 5% Glyc + 0.02 M Triton-X100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2" name="TextBox 21"/>
          <p:cNvSpPr txBox="1"/>
          <p:nvPr/>
        </p:nvSpPr>
        <p:spPr>
          <a:xfrm rot="16200000">
            <a:off x="5761480" y="3686219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quisetum arvense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165 M </a:t>
            </a:r>
            <a:r>
              <a:rPr lang="en-GB" sz="800" b="1" dirty="0"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trat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Oval 32"/>
          <p:cNvSpPr/>
          <p:nvPr/>
        </p:nvSpPr>
        <p:spPr>
          <a:xfrm>
            <a:off x="2173351" y="2844063"/>
            <a:ext cx="323850" cy="323850"/>
          </a:xfrm>
          <a:prstGeom prst="ellipse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 dirty="0"/>
          </a:p>
        </p:txBody>
      </p:sp>
      <p:sp>
        <p:nvSpPr>
          <p:cNvPr id="34" name="Oval 33"/>
          <p:cNvSpPr/>
          <p:nvPr/>
        </p:nvSpPr>
        <p:spPr>
          <a:xfrm>
            <a:off x="2509901" y="2844063"/>
            <a:ext cx="323850" cy="323850"/>
          </a:xfrm>
          <a:prstGeom prst="ellipse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 dirty="0"/>
          </a:p>
        </p:txBody>
      </p:sp>
      <p:sp>
        <p:nvSpPr>
          <p:cNvPr id="35" name="Oval 34"/>
          <p:cNvSpPr/>
          <p:nvPr/>
        </p:nvSpPr>
        <p:spPr>
          <a:xfrm>
            <a:off x="2852166" y="2844063"/>
            <a:ext cx="323850" cy="323850"/>
          </a:xfrm>
          <a:prstGeom prst="ellipse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 dirty="0"/>
          </a:p>
        </p:txBody>
      </p:sp>
      <p:sp>
        <p:nvSpPr>
          <p:cNvPr id="36" name="Oval 35"/>
          <p:cNvSpPr/>
          <p:nvPr/>
        </p:nvSpPr>
        <p:spPr>
          <a:xfrm>
            <a:off x="1830451" y="2844063"/>
            <a:ext cx="323850" cy="323850"/>
          </a:xfrm>
          <a:prstGeom prst="ellipse">
            <a:avLst/>
          </a:prstGeom>
          <a:noFill/>
          <a:ln w="158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 dirty="0"/>
          </a:p>
        </p:txBody>
      </p:sp>
      <p:grpSp>
        <p:nvGrpSpPr>
          <p:cNvPr id="69" name="Group 68"/>
          <p:cNvGrpSpPr/>
          <p:nvPr/>
        </p:nvGrpSpPr>
        <p:grpSpPr>
          <a:xfrm>
            <a:off x="3999830" y="2784240"/>
            <a:ext cx="2520000" cy="453034"/>
            <a:chOff x="3920677" y="3605634"/>
            <a:chExt cx="2520000" cy="453034"/>
          </a:xfrm>
        </p:grpSpPr>
        <p:pic>
          <p:nvPicPr>
            <p:cNvPr id="68" name="Picture 67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920677" y="3605634"/>
              <a:ext cx="2520000" cy="453034"/>
            </a:xfrm>
            <a:prstGeom prst="rect">
              <a:avLst/>
            </a:prstGeom>
          </p:spPr>
        </p:pic>
        <p:sp>
          <p:nvSpPr>
            <p:cNvPr id="37" name="Oval 36"/>
            <p:cNvSpPr/>
            <p:nvPr/>
          </p:nvSpPr>
          <p:spPr>
            <a:xfrm>
              <a:off x="4679027" y="3665457"/>
              <a:ext cx="323850" cy="323850"/>
            </a:xfrm>
            <a:prstGeom prst="ellipse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  <p:sp>
          <p:nvSpPr>
            <p:cNvPr id="38" name="Oval 37"/>
            <p:cNvSpPr/>
            <p:nvPr/>
          </p:nvSpPr>
          <p:spPr>
            <a:xfrm>
              <a:off x="5015577" y="3665457"/>
              <a:ext cx="323850" cy="323850"/>
            </a:xfrm>
            <a:prstGeom prst="ellipse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  <p:sp>
          <p:nvSpPr>
            <p:cNvPr id="39" name="Oval 38"/>
            <p:cNvSpPr/>
            <p:nvPr/>
          </p:nvSpPr>
          <p:spPr>
            <a:xfrm>
              <a:off x="5357842" y="3665457"/>
              <a:ext cx="323850" cy="323850"/>
            </a:xfrm>
            <a:prstGeom prst="ellipse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  <p:sp>
          <p:nvSpPr>
            <p:cNvPr id="40" name="Oval 39"/>
            <p:cNvSpPr/>
            <p:nvPr/>
          </p:nvSpPr>
          <p:spPr>
            <a:xfrm>
              <a:off x="4336127" y="3665457"/>
              <a:ext cx="323850" cy="323850"/>
            </a:xfrm>
            <a:prstGeom prst="ellipse">
              <a:avLst/>
            </a:prstGeom>
            <a:noFill/>
            <a:ln w="15875"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 dirty="0"/>
            </a:p>
          </p:txBody>
        </p:sp>
      </p:grpSp>
      <p:pic>
        <p:nvPicPr>
          <p:cNvPr id="47" name="Picture 46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2281" y="1241772"/>
            <a:ext cx="2520000" cy="454054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6655" y="738188"/>
            <a:ext cx="2520000" cy="454054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2281" y="1748301"/>
            <a:ext cx="2520000" cy="452018"/>
          </a:xfrm>
          <a:prstGeom prst="rect">
            <a:avLst/>
          </a:prstGeom>
        </p:spPr>
      </p:pic>
      <p:pic>
        <p:nvPicPr>
          <p:cNvPr id="62" name="Picture 61"/>
          <p:cNvPicPr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9830" y="2265540"/>
            <a:ext cx="2520000" cy="453600"/>
          </a:xfrm>
          <a:prstGeom prst="rect">
            <a:avLst/>
          </a:prstGeom>
        </p:spPr>
      </p:pic>
      <p:sp>
        <p:nvSpPr>
          <p:cNvPr id="45" name="Rectangle 44"/>
          <p:cNvSpPr/>
          <p:nvPr/>
        </p:nvSpPr>
        <p:spPr>
          <a:xfrm>
            <a:off x="567815" y="4626620"/>
            <a:ext cx="6480720" cy="2631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ot-blot assay for trans-β-mannanase activity extracted from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hara vulgaris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and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Equisetum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spp.</a:t>
            </a:r>
          </a:p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dot-blot assay was performed on test paper impregnated with 0.2% konjac glucomannan and 2.4 µM Man</a:t>
            </a:r>
            <a:r>
              <a:rPr lang="en-GB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SR. Enzyme extract (5 µl) was loaded onto dry dot-blot paper, then incubated for 24 h under humid conditions. The dot-blot was then dried and subsequently washed with 80, 60, 40, 20 and 10% ethanol supplemented with 0.5% acetic acid, each for 1 h, and documented in a Doc-It imaging system.  </a:t>
            </a:r>
          </a:p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verse extractants were used to extract enzymes from wild and axenic </a:t>
            </a:r>
            <a:r>
              <a:rPr lang="en-GB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ara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from </a:t>
            </a:r>
            <a:r>
              <a:rPr lang="en-GB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quisetum fluviatile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GB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. arvense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tems. CE, crude extract; D, dialysed extract; AS, ammonium sulphate; EtOH, ethanol, AA, acetic acid; </a:t>
            </a:r>
            <a:r>
              <a:rPr lang="en-GB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cc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succinate; </a:t>
            </a:r>
            <a:r>
              <a:rPr lang="en-GB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lyc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15% glycerol; </a:t>
            </a:r>
            <a:r>
              <a:rPr lang="en-GB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sc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20 mM ascorbate.</a:t>
            </a:r>
          </a:p>
          <a:p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like the two representatives of ferns (</a:t>
            </a:r>
            <a:r>
              <a:rPr lang="en-GB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. arvense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GB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. fluviatile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</a:t>
            </a:r>
            <a:r>
              <a:rPr lang="en-GB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ara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hibits high endo-acting </a:t>
            </a:r>
            <a:r>
              <a:rPr lang="en-GB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BM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ctivity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21"/>
          <p:cNvSpPr txBox="1"/>
          <p:nvPr/>
        </p:nvSpPr>
        <p:spPr>
          <a:xfrm rot="16200000">
            <a:off x="5411594" y="3681773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 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oiled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3 M Succ + Glyc + Asc</a:t>
            </a: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u="sng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Control)  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8" name="TextBox 21"/>
          <p:cNvSpPr txBox="1"/>
          <p:nvPr/>
        </p:nvSpPr>
        <p:spPr>
          <a:xfrm rot="16200000">
            <a:off x="2804871" y="3674949"/>
            <a:ext cx="1079500" cy="261620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i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hara vulgaris 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oiled </a:t>
            </a:r>
            <a:r>
              <a:rPr lang="en-GB" sz="800" b="1" kern="1200" dirty="0">
                <a:solidFill>
                  <a:srgbClr val="006600"/>
                </a:solidFill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E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0.3M Succ + Glyc + Asc</a:t>
            </a:r>
          </a:p>
          <a:p>
            <a:pPr algn="r" fontAlgn="base">
              <a:lnSpc>
                <a:spcPts val="8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800" b="1" u="sng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Control)</a:t>
            </a:r>
            <a:r>
              <a:rPr lang="en-GB" sz="800" b="1" kern="1200" dirty="0">
                <a:effectLst/>
                <a:latin typeface="Arial Narrow" panose="020B0606020202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         </a:t>
            </a:r>
            <a:endParaRPr lang="en-GB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4443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468263" y="8515340"/>
            <a:ext cx="6480720" cy="20159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s for kinetic properties of oligomannan-remodelling transglycosylases extracted from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Chara vulgaris</a:t>
            </a:r>
          </a:p>
          <a:p>
            <a:pPr>
              <a:spcAft>
                <a:spcPts val="600"/>
              </a:spcAft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A) Control (i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ime-dependent action on 0.1 µM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ol (acceptor) mixed with 3000 µM 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donor) and heat-inactivated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har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extract. Values from Control (i) were used to correct values as shown in Figure 7C. </a:t>
            </a:r>
          </a:p>
          <a:p>
            <a:pPr>
              <a:spcAft>
                <a:spcPts val="600"/>
              </a:spcAft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B) Control (i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Effect of substrate concentration on products formed by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har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ransglycosylases and hydrolases after 24 h. Dried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6-ol was re-dissolved at various concentrations (0–3027 µM) of 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, mixed with heat-inactivated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har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extract and incubated at 22°C for 24 h. Values from Control (i) were used to correct values as shown in Figure 7D. </a:t>
            </a:r>
          </a:p>
          <a:p>
            <a:pPr>
              <a:spcAft>
                <a:spcPts val="600"/>
              </a:spcAft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C) Control (ii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Effect of substrate concentration on products formed by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har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ransglycosylases and hydrolases after 24 h. Dried [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]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ol was re-dissolved at various concentrations (0–3027 µM) of Man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, mixed buffer free of enzyme and incubated at 22°C for 24 h.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3496" y="2849393"/>
            <a:ext cx="2932965" cy="2772000"/>
          </a:xfrm>
          <a:prstGeom prst="rect">
            <a:avLst/>
          </a:prstGeom>
        </p:spPr>
      </p:pic>
      <p:sp>
        <p:nvSpPr>
          <p:cNvPr id="48" name="Rectangle 601"/>
          <p:cNvSpPr>
            <a:spLocks noChangeArrowheads="1"/>
          </p:cNvSpPr>
          <p:nvPr/>
        </p:nvSpPr>
        <p:spPr bwMode="auto">
          <a:xfrm>
            <a:off x="2130106" y="86312"/>
            <a:ext cx="2880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6000" tIns="0" rIns="36000" bIns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(A)</a:t>
            </a:r>
            <a:endParaRPr kumimoji="0" lang="en-GB" sz="12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Rectangle 601"/>
          <p:cNvSpPr>
            <a:spLocks noChangeArrowheads="1"/>
          </p:cNvSpPr>
          <p:nvPr/>
        </p:nvSpPr>
        <p:spPr bwMode="auto">
          <a:xfrm>
            <a:off x="2118074" y="2889670"/>
            <a:ext cx="2880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6000" tIns="0" rIns="36000" bIns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(B)</a:t>
            </a:r>
            <a:endParaRPr kumimoji="0" lang="en-GB" sz="12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ectangle 601"/>
          <p:cNvSpPr>
            <a:spLocks noChangeArrowheads="1"/>
          </p:cNvSpPr>
          <p:nvPr/>
        </p:nvSpPr>
        <p:spPr bwMode="auto">
          <a:xfrm>
            <a:off x="2130106" y="5677399"/>
            <a:ext cx="28800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6000" tIns="0" rIns="36000" bIns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(C)</a:t>
            </a:r>
            <a:endParaRPr kumimoji="0" lang="en-GB" sz="12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 Box 2"/>
          <p:cNvSpPr txBox="1">
            <a:spLocks noChangeArrowheads="1"/>
          </p:cNvSpPr>
          <p:nvPr/>
        </p:nvSpPr>
        <p:spPr bwMode="auto">
          <a:xfrm rot="16200000">
            <a:off x="1731912" y="3372881"/>
            <a:ext cx="14678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GB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% of total radioactivity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Text Box 2"/>
          <p:cNvSpPr txBox="1">
            <a:spLocks noChangeArrowheads="1"/>
          </p:cNvSpPr>
          <p:nvPr/>
        </p:nvSpPr>
        <p:spPr bwMode="auto">
          <a:xfrm rot="16200000">
            <a:off x="1747025" y="6136115"/>
            <a:ext cx="14678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GB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% of total radioactivity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Text Box 2"/>
          <p:cNvSpPr txBox="1">
            <a:spLocks noChangeArrowheads="1"/>
          </p:cNvSpPr>
          <p:nvPr/>
        </p:nvSpPr>
        <p:spPr bwMode="auto">
          <a:xfrm rot="16200000">
            <a:off x="1776522" y="613467"/>
            <a:ext cx="14678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en-GB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% of total radioactivity</a:t>
            </a:r>
            <a:endParaRPr kumimoji="0" lang="en-US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2461" y="48260"/>
            <a:ext cx="2934000" cy="277116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72461" y="5645189"/>
            <a:ext cx="2934000" cy="2771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0136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43</TotalTime>
  <Words>1053</Words>
  <Application>Microsoft Office PowerPoint</Application>
  <PresentationFormat>Custom</PresentationFormat>
  <Paragraphs>8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Arial Narrow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o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rankova</dc:creator>
  <cp:lastModifiedBy>Stephen Fry</cp:lastModifiedBy>
  <cp:revision>1561</cp:revision>
  <cp:lastPrinted>2023-11-01T06:32:36Z</cp:lastPrinted>
  <dcterms:created xsi:type="dcterms:W3CDTF">2013-10-31T19:52:06Z</dcterms:created>
  <dcterms:modified xsi:type="dcterms:W3CDTF">2023-12-06T22:56:33Z</dcterms:modified>
</cp:coreProperties>
</file>